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10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3838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01362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77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18312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52964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73769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9372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9430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56209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24974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17923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FA7D6-2B87-4BAD-9FA4-2A9DC2C9BA31}" type="datetimeFigureOut">
              <a:rPr lang="nl-NL" smtClean="0"/>
              <a:t>7-4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B9011-A63B-4060-93BD-D6E6946EAC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81446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732240" y="8785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10</a:t>
            </a:r>
            <a:endParaRPr lang="nl-NL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6732240" y="12385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6732240" y="15986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5</a:t>
            </a:r>
            <a:endParaRPr lang="nl-NL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6718895" y="19586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6732240" y="26787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6732240" y="23186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6732240" y="30387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6732240" y="33988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6732240" y="37588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2</a:t>
            </a:r>
            <a:endParaRPr lang="nl-NL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6718895" y="41188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6732240" y="48389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1</a:t>
            </a:r>
            <a:endParaRPr lang="nl-NL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6732240" y="44789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/>
              <a:t>4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732240" y="51990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6737945" y="55590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6732240" y="62791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6732240" y="59190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3</a:t>
            </a:r>
            <a:endParaRPr lang="nl-NL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5292080" y="8785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36</a:t>
            </a:r>
            <a:endParaRPr lang="nl-NL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5292080" y="12385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5</a:t>
            </a:r>
            <a:endParaRPr lang="nl-NL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5292080" y="15986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24</a:t>
            </a:r>
            <a:endParaRPr lang="nl-NL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5297785" y="19586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7</a:t>
            </a:r>
            <a:endParaRPr lang="nl-NL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5292080" y="26787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0</a:t>
            </a:r>
            <a:endParaRPr lang="nl-NL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5292080" y="23186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2</a:t>
            </a:r>
            <a:endParaRPr lang="nl-NL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5292080" y="30387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7</a:t>
            </a:r>
            <a:endParaRPr lang="nl-NL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5292080" y="33988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7</a:t>
            </a:r>
            <a:endParaRPr lang="nl-NL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5292080" y="37588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9</a:t>
            </a:r>
            <a:endParaRPr lang="nl-NL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5297785" y="41188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1</a:t>
            </a:r>
            <a:endParaRPr lang="nl-NL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5292080" y="483896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21</a:t>
            </a:r>
            <a:endParaRPr lang="nl-NL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5292080" y="44789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82</a:t>
            </a:r>
            <a:endParaRPr lang="nl-NL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5292080" y="519900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0</a:t>
            </a:r>
            <a:endParaRPr lang="nl-NL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5297785" y="555904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0</a:t>
            </a:r>
            <a:endParaRPr lang="nl-NL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5292080" y="627912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11</a:t>
            </a:r>
            <a:endParaRPr lang="nl-NL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5292080" y="5919083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57</a:t>
            </a:r>
            <a:endParaRPr lang="nl-NL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3851920" y="109454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41</a:t>
            </a:r>
            <a:endParaRPr lang="nl-NL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3851920" y="181462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31</a:t>
            </a:r>
            <a:endParaRPr lang="nl-NL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3851920" y="325478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14</a:t>
            </a:r>
            <a:endParaRPr lang="nl-NL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3851920" y="253470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2</a:t>
            </a:r>
            <a:endParaRPr lang="nl-NL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3851920" y="397486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10</a:t>
            </a:r>
            <a:endParaRPr lang="nl-NL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3851920" y="469494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- 103</a:t>
            </a:r>
            <a:endParaRPr lang="nl-NL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3851920" y="613510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68</a:t>
            </a:r>
            <a:endParaRPr lang="nl-NL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3851920" y="541502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0</a:t>
            </a:r>
            <a:endParaRPr lang="nl-NL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2411760" y="145458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72</a:t>
            </a:r>
            <a:endParaRPr lang="nl-NL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2411760" y="289474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/>
              <a:t>L</a:t>
            </a:r>
            <a:r>
              <a:rPr lang="nl-NL" sz="1000" dirty="0" smtClean="0"/>
              <a:t>R = 16</a:t>
            </a:r>
            <a:endParaRPr lang="nl-NL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2411760" y="577506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68</a:t>
            </a:r>
            <a:endParaRPr lang="nl-NL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2411760" y="433490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113</a:t>
            </a:r>
            <a:endParaRPr lang="nl-NL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971600" y="505498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LR = 181</a:t>
            </a:r>
            <a:endParaRPr lang="nl-NL" sz="1000" dirty="0"/>
          </a:p>
        </p:txBody>
      </p:sp>
      <p:sp>
        <p:nvSpPr>
          <p:cNvPr id="50" name="TextBox 49"/>
          <p:cNvSpPr txBox="1"/>
          <p:nvPr/>
        </p:nvSpPr>
        <p:spPr>
          <a:xfrm>
            <a:off x="971600" y="2174667"/>
            <a:ext cx="733425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HR = 88</a:t>
            </a:r>
            <a:endParaRPr lang="nl-NL" sz="1000" dirty="0"/>
          </a:p>
        </p:txBody>
      </p:sp>
      <p:sp>
        <p:nvSpPr>
          <p:cNvPr id="55" name="TextBox 54"/>
          <p:cNvSpPr txBox="1"/>
          <p:nvPr/>
        </p:nvSpPr>
        <p:spPr>
          <a:xfrm>
            <a:off x="5253980" y="260648"/>
            <a:ext cx="792088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Not always condoms last 6m</a:t>
            </a:r>
            <a:endParaRPr lang="nl-NL" sz="1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6732240" y="260648"/>
            <a:ext cx="733425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Tested in the last 6m</a:t>
            </a:r>
            <a:endParaRPr lang="nl-NL" sz="10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3851920" y="260648"/>
            <a:ext cx="733425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Multiple partners last 6m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411760" y="260648"/>
            <a:ext cx="733425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New partner last 6m</a:t>
            </a:r>
            <a:endParaRPr lang="nl-NL" sz="10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971600" y="260648"/>
            <a:ext cx="733425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Multiple partners at T0</a:t>
            </a:r>
            <a:endParaRPr lang="nl-NL" sz="1000" b="1" dirty="0"/>
          </a:p>
        </p:txBody>
      </p:sp>
      <p:cxnSp>
        <p:nvCxnSpPr>
          <p:cNvPr id="61" name="Straight Connector 60"/>
          <p:cNvCxnSpPr>
            <a:stCxn id="50" idx="3"/>
            <a:endCxn id="45" idx="1"/>
          </p:cNvCxnSpPr>
          <p:nvPr/>
        </p:nvCxnSpPr>
        <p:spPr>
          <a:xfrm flipV="1">
            <a:off x="1705025" y="1577698"/>
            <a:ext cx="706735" cy="720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>
            <a:stCxn id="50" idx="3"/>
            <a:endCxn id="46" idx="1"/>
          </p:cNvCxnSpPr>
          <p:nvPr/>
        </p:nvCxnSpPr>
        <p:spPr>
          <a:xfrm>
            <a:off x="1705025" y="2297778"/>
            <a:ext cx="706735" cy="720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>
            <a:stCxn id="49" idx="3"/>
            <a:endCxn id="48" idx="1"/>
          </p:cNvCxnSpPr>
          <p:nvPr/>
        </p:nvCxnSpPr>
        <p:spPr>
          <a:xfrm flipV="1">
            <a:off x="1705025" y="4458018"/>
            <a:ext cx="706735" cy="720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>
            <a:stCxn id="49" idx="3"/>
            <a:endCxn id="47" idx="1"/>
          </p:cNvCxnSpPr>
          <p:nvPr/>
        </p:nvCxnSpPr>
        <p:spPr>
          <a:xfrm>
            <a:off x="1705025" y="5178098"/>
            <a:ext cx="706735" cy="720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>
            <a:stCxn id="45" idx="3"/>
            <a:endCxn id="37" idx="1"/>
          </p:cNvCxnSpPr>
          <p:nvPr/>
        </p:nvCxnSpPr>
        <p:spPr>
          <a:xfrm flipV="1">
            <a:off x="3145185" y="121765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>
            <a:stCxn id="45" idx="3"/>
            <a:endCxn id="38" idx="1"/>
          </p:cNvCxnSpPr>
          <p:nvPr/>
        </p:nvCxnSpPr>
        <p:spPr>
          <a:xfrm>
            <a:off x="3145185" y="157769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>
            <a:stCxn id="46" idx="3"/>
            <a:endCxn id="40" idx="1"/>
          </p:cNvCxnSpPr>
          <p:nvPr/>
        </p:nvCxnSpPr>
        <p:spPr>
          <a:xfrm flipV="1">
            <a:off x="3145185" y="265781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>
            <a:stCxn id="46" idx="3"/>
            <a:endCxn id="39" idx="1"/>
          </p:cNvCxnSpPr>
          <p:nvPr/>
        </p:nvCxnSpPr>
        <p:spPr>
          <a:xfrm>
            <a:off x="3145185" y="301785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>
            <a:stCxn id="48" idx="3"/>
            <a:endCxn id="41" idx="1"/>
          </p:cNvCxnSpPr>
          <p:nvPr/>
        </p:nvCxnSpPr>
        <p:spPr>
          <a:xfrm flipV="1">
            <a:off x="3145185" y="409797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>
            <a:stCxn id="48" idx="3"/>
            <a:endCxn id="42" idx="1"/>
          </p:cNvCxnSpPr>
          <p:nvPr/>
        </p:nvCxnSpPr>
        <p:spPr>
          <a:xfrm>
            <a:off x="3145185" y="445801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>
            <a:stCxn id="47" idx="3"/>
            <a:endCxn id="44" idx="1"/>
          </p:cNvCxnSpPr>
          <p:nvPr/>
        </p:nvCxnSpPr>
        <p:spPr>
          <a:xfrm flipV="1">
            <a:off x="3145185" y="553813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>
            <a:stCxn id="47" idx="3"/>
            <a:endCxn id="43" idx="1"/>
          </p:cNvCxnSpPr>
          <p:nvPr/>
        </p:nvCxnSpPr>
        <p:spPr>
          <a:xfrm>
            <a:off x="3145185" y="5898178"/>
            <a:ext cx="706735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>
            <a:stCxn id="37" idx="3"/>
            <a:endCxn id="21" idx="1"/>
          </p:cNvCxnSpPr>
          <p:nvPr/>
        </p:nvCxnSpPr>
        <p:spPr>
          <a:xfrm flipV="1">
            <a:off x="4585345" y="100163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>
            <a:stCxn id="37" idx="3"/>
            <a:endCxn id="22" idx="1"/>
          </p:cNvCxnSpPr>
          <p:nvPr/>
        </p:nvCxnSpPr>
        <p:spPr>
          <a:xfrm>
            <a:off x="4585345" y="1217658"/>
            <a:ext cx="706735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>
            <a:stCxn id="38" idx="3"/>
            <a:endCxn id="23" idx="1"/>
          </p:cNvCxnSpPr>
          <p:nvPr/>
        </p:nvCxnSpPr>
        <p:spPr>
          <a:xfrm flipV="1">
            <a:off x="4585345" y="172171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>
            <a:stCxn id="38" idx="3"/>
            <a:endCxn id="24" idx="1"/>
          </p:cNvCxnSpPr>
          <p:nvPr/>
        </p:nvCxnSpPr>
        <p:spPr>
          <a:xfrm>
            <a:off x="4585345" y="1937738"/>
            <a:ext cx="71244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>
            <a:stCxn id="40" idx="3"/>
            <a:endCxn id="26" idx="1"/>
          </p:cNvCxnSpPr>
          <p:nvPr/>
        </p:nvCxnSpPr>
        <p:spPr>
          <a:xfrm flipV="1">
            <a:off x="4585345" y="244179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>
            <a:stCxn id="40" idx="3"/>
            <a:endCxn id="25" idx="1"/>
          </p:cNvCxnSpPr>
          <p:nvPr/>
        </p:nvCxnSpPr>
        <p:spPr>
          <a:xfrm>
            <a:off x="4585345" y="2657818"/>
            <a:ext cx="706735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>
            <a:stCxn id="39" idx="3"/>
            <a:endCxn id="27" idx="1"/>
          </p:cNvCxnSpPr>
          <p:nvPr/>
        </p:nvCxnSpPr>
        <p:spPr>
          <a:xfrm flipV="1">
            <a:off x="4585345" y="316187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>
            <a:stCxn id="39" idx="3"/>
            <a:endCxn id="28" idx="1"/>
          </p:cNvCxnSpPr>
          <p:nvPr/>
        </p:nvCxnSpPr>
        <p:spPr>
          <a:xfrm>
            <a:off x="4585345" y="3377898"/>
            <a:ext cx="706735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>
            <a:stCxn id="41" idx="3"/>
            <a:endCxn id="29" idx="1"/>
          </p:cNvCxnSpPr>
          <p:nvPr/>
        </p:nvCxnSpPr>
        <p:spPr>
          <a:xfrm flipV="1">
            <a:off x="4585345" y="388195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>
            <a:stCxn id="41" idx="3"/>
            <a:endCxn id="30" idx="1"/>
          </p:cNvCxnSpPr>
          <p:nvPr/>
        </p:nvCxnSpPr>
        <p:spPr>
          <a:xfrm>
            <a:off x="4585345" y="4097978"/>
            <a:ext cx="71244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>
            <a:stCxn id="42" idx="3"/>
            <a:endCxn id="32" idx="1"/>
          </p:cNvCxnSpPr>
          <p:nvPr/>
        </p:nvCxnSpPr>
        <p:spPr>
          <a:xfrm flipV="1">
            <a:off x="4585345" y="460203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stCxn id="42" idx="3"/>
            <a:endCxn id="31" idx="1"/>
          </p:cNvCxnSpPr>
          <p:nvPr/>
        </p:nvCxnSpPr>
        <p:spPr>
          <a:xfrm>
            <a:off x="4585345" y="4818058"/>
            <a:ext cx="706735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>
            <a:stCxn id="44" idx="3"/>
            <a:endCxn id="33" idx="1"/>
          </p:cNvCxnSpPr>
          <p:nvPr/>
        </p:nvCxnSpPr>
        <p:spPr>
          <a:xfrm flipV="1">
            <a:off x="4585345" y="532211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>
            <a:stCxn id="44" idx="3"/>
            <a:endCxn id="34" idx="1"/>
          </p:cNvCxnSpPr>
          <p:nvPr/>
        </p:nvCxnSpPr>
        <p:spPr>
          <a:xfrm>
            <a:off x="4585345" y="5538138"/>
            <a:ext cx="71244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>
            <a:stCxn id="43" idx="3"/>
            <a:endCxn id="36" idx="1"/>
          </p:cNvCxnSpPr>
          <p:nvPr/>
        </p:nvCxnSpPr>
        <p:spPr>
          <a:xfrm flipV="1">
            <a:off x="4585345" y="6042194"/>
            <a:ext cx="706735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>
            <a:stCxn id="43" idx="3"/>
            <a:endCxn id="35" idx="1"/>
          </p:cNvCxnSpPr>
          <p:nvPr/>
        </p:nvCxnSpPr>
        <p:spPr>
          <a:xfrm>
            <a:off x="4585345" y="6258218"/>
            <a:ext cx="706735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>
            <a:stCxn id="21" idx="3"/>
            <a:endCxn id="4" idx="1"/>
          </p:cNvCxnSpPr>
          <p:nvPr/>
        </p:nvCxnSpPr>
        <p:spPr>
          <a:xfrm>
            <a:off x="6025505" y="100163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>
            <a:stCxn id="22" idx="3"/>
            <a:endCxn id="6" idx="1"/>
          </p:cNvCxnSpPr>
          <p:nvPr/>
        </p:nvCxnSpPr>
        <p:spPr>
          <a:xfrm>
            <a:off x="6025505" y="136167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>
            <a:stCxn id="23" idx="3"/>
            <a:endCxn id="7" idx="1"/>
          </p:cNvCxnSpPr>
          <p:nvPr/>
        </p:nvCxnSpPr>
        <p:spPr>
          <a:xfrm>
            <a:off x="6025505" y="172171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>
            <a:stCxn id="24" idx="3"/>
            <a:endCxn id="8" idx="1"/>
          </p:cNvCxnSpPr>
          <p:nvPr/>
        </p:nvCxnSpPr>
        <p:spPr>
          <a:xfrm>
            <a:off x="6031210" y="2081754"/>
            <a:ext cx="68768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>
            <a:stCxn id="26" idx="3"/>
            <a:endCxn id="10" idx="1"/>
          </p:cNvCxnSpPr>
          <p:nvPr/>
        </p:nvCxnSpPr>
        <p:spPr>
          <a:xfrm>
            <a:off x="6025505" y="244179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>
            <a:stCxn id="25" idx="3"/>
            <a:endCxn id="9" idx="1"/>
          </p:cNvCxnSpPr>
          <p:nvPr/>
        </p:nvCxnSpPr>
        <p:spPr>
          <a:xfrm>
            <a:off x="6025505" y="280183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>
            <a:stCxn id="27" idx="3"/>
            <a:endCxn id="11" idx="1"/>
          </p:cNvCxnSpPr>
          <p:nvPr/>
        </p:nvCxnSpPr>
        <p:spPr>
          <a:xfrm>
            <a:off x="6025505" y="316187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>
            <a:stCxn id="28" idx="3"/>
            <a:endCxn id="12" idx="1"/>
          </p:cNvCxnSpPr>
          <p:nvPr/>
        </p:nvCxnSpPr>
        <p:spPr>
          <a:xfrm>
            <a:off x="6025505" y="352191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>
            <a:stCxn id="29" idx="3"/>
            <a:endCxn id="13" idx="1"/>
          </p:cNvCxnSpPr>
          <p:nvPr/>
        </p:nvCxnSpPr>
        <p:spPr>
          <a:xfrm>
            <a:off x="6025505" y="388195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>
            <a:stCxn id="30" idx="3"/>
            <a:endCxn id="14" idx="1"/>
          </p:cNvCxnSpPr>
          <p:nvPr/>
        </p:nvCxnSpPr>
        <p:spPr>
          <a:xfrm>
            <a:off x="6031210" y="4241994"/>
            <a:ext cx="68768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>
            <a:stCxn id="32" idx="3"/>
            <a:endCxn id="16" idx="1"/>
          </p:cNvCxnSpPr>
          <p:nvPr/>
        </p:nvCxnSpPr>
        <p:spPr>
          <a:xfrm>
            <a:off x="6025505" y="460203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/>
          <p:cNvCxnSpPr>
            <a:stCxn id="31" idx="3"/>
            <a:endCxn id="15" idx="1"/>
          </p:cNvCxnSpPr>
          <p:nvPr/>
        </p:nvCxnSpPr>
        <p:spPr>
          <a:xfrm>
            <a:off x="6025505" y="496207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>
            <a:stCxn id="33" idx="3"/>
            <a:endCxn id="17" idx="1"/>
          </p:cNvCxnSpPr>
          <p:nvPr/>
        </p:nvCxnSpPr>
        <p:spPr>
          <a:xfrm>
            <a:off x="6025505" y="532211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/>
          <p:cNvCxnSpPr>
            <a:stCxn id="34" idx="3"/>
            <a:endCxn id="18" idx="1"/>
          </p:cNvCxnSpPr>
          <p:nvPr/>
        </p:nvCxnSpPr>
        <p:spPr>
          <a:xfrm>
            <a:off x="6031210" y="568215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>
            <a:stCxn id="36" idx="3"/>
            <a:endCxn id="20" idx="1"/>
          </p:cNvCxnSpPr>
          <p:nvPr/>
        </p:nvCxnSpPr>
        <p:spPr>
          <a:xfrm>
            <a:off x="6025505" y="604219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/>
          <p:cNvCxnSpPr>
            <a:stCxn id="35" idx="3"/>
            <a:endCxn id="19" idx="1"/>
          </p:cNvCxnSpPr>
          <p:nvPr/>
        </p:nvCxnSpPr>
        <p:spPr>
          <a:xfrm>
            <a:off x="6025505" y="6402234"/>
            <a:ext cx="70673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87613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28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astricht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. Kok</dc:creator>
  <cp:lastModifiedBy>G. Kok</cp:lastModifiedBy>
  <cp:revision>8</cp:revision>
  <dcterms:created xsi:type="dcterms:W3CDTF">2015-04-07T19:22:11Z</dcterms:created>
  <dcterms:modified xsi:type="dcterms:W3CDTF">2015-04-07T20:01:59Z</dcterms:modified>
</cp:coreProperties>
</file>